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docx" ContentType="application/vnd.openxmlformats-officedocument.wordprocessingml.document"/>
  <Override PartName="/ppt/media/image1.pct" ContentType="image/x-pict"/>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7E9C97E-2391-4A24-9115-E1A3FC50318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EBFD991-69E6-4823-9C3A-2645502A1EE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2D92BD7-269C-4B26-B402-FF312E5837E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DB3D48F-1C21-4252-87C5-08B315F5B0B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DE13058-79A8-4B6C-B576-C5F4F3B8528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1EDA86A-548D-4A9C-9BD6-18F54AC9BB3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1881FCC-7234-41CA-81FB-2074B9C6365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AF64F57-3992-4E1B-AC83-A4F61B864E4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5AEFEF6-07F8-4C57-AEC7-A79DFD89553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DE7C166-7015-45ED-AE4C-23809233ACB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6C9ECB-7F28-44BC-B4D3-F2DB00124D0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163F53E-5D3A-4957-B3C8-B3391F01C9A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A7C6D38-A107-4F80-A1D9-84EAA1CE06D3}"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docx"/><Relationship Id="rId2" Type="http://schemas.openxmlformats.org/officeDocument/2006/relationships/image" Target="../media/image1.pct"/><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2209680" y="304920"/>
          <a:ext cx="4267440" cy="3801960"/>
        </p:xfrm>
        <a:graphic>
          <a:graphicData uri="http://schemas.openxmlformats.org/presentationml/2006/ole">
            <p:oleObj progId="Word.Document.12" r:id="rId1" spid="">
              <p:embed/>
              <p:pic>
                <p:nvPicPr>
                  <p:cNvPr id="42" name="" descr=""/>
                  <p:cNvPicPr/>
                  <p:nvPr/>
                </p:nvPicPr>
                <p:blipFill>
                  <a:blip r:embed="rId2"/>
                  <a:stretch/>
                </p:blipFill>
                <p:spPr>
                  <a:xfrm>
                    <a:off x="2209680" y="304920"/>
                    <a:ext cx="4267440" cy="3801960"/>
                  </a:xfrm>
                  <a:prstGeom prst="rect">
                    <a:avLst/>
                  </a:prstGeom>
                  <a:ln w="0">
                    <a:noFill/>
                  </a:ln>
                </p:spPr>
              </p:pic>
            </p:oleObj>
          </a:graphicData>
        </a:graphic>
      </p:graphicFrame>
      <p:sp>
        <p:nvSpPr>
          <p:cNvPr id="43" name=""/>
          <p:cNvSpPr/>
          <p:nvPr/>
        </p:nvSpPr>
        <p:spPr>
          <a:xfrm>
            <a:off x="0" y="4392720"/>
            <a:ext cx="9144000" cy="22842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宋体"/>
              </a:rPr>
              <a:t>Figure S1.  FM4-64 staining reveals that the </a:t>
            </a:r>
            <a:r>
              <a:rPr b="0" i="1" lang="en-US" sz="1200" spc="-1" strike="noStrike">
                <a:solidFill>
                  <a:srgbClr val="000000"/>
                </a:solidFill>
                <a:latin typeface="Times New Roman"/>
                <a:ea typeface="宋体"/>
              </a:rPr>
              <a:t>Mosec22</a:t>
            </a:r>
            <a:r>
              <a:rPr b="0" lang="en-US" sz="1200" spc="-1" strike="noStrike">
                <a:solidFill>
                  <a:srgbClr val="000000"/>
                </a:solidFill>
                <a:latin typeface="Times New Roman"/>
                <a:ea typeface="宋体"/>
              </a:rPr>
              <a:t> mutant is defective in endocytosis.  FM4-64 staining was conducted following procedures previously described (Fischer-Parton, et al., 2000; Weber et al., 2001).   Stains were grown for 2 days on CM-overlaid microscope slides and exposed to FM4-64.  Fluorescence was observed under a Leica DMR microscope (Leica Microsystems, Wetzlar, Germany) and pictures taken after 10 and 30 min exposures.  Camera exposure time is indicated in second.  In the wild-type strain, FM4-64 appeared to be in the plasma membrane within 5 min and inside the plasma membrane within 10 min (Fig. S1B).  In contrast, the dye uptake in the </a:t>
            </a:r>
            <a:r>
              <a:rPr b="0" i="1" lang="en-US" sz="1200" spc="-1" strike="noStrike">
                <a:solidFill>
                  <a:srgbClr val="000000"/>
                </a:solidFill>
                <a:latin typeface="Times New Roman"/>
                <a:ea typeface="宋体"/>
              </a:rPr>
              <a:t>∆Mosec22 </a:t>
            </a:r>
            <a:r>
              <a:rPr b="0" lang="en-US" sz="1200" spc="-1" strike="noStrike">
                <a:solidFill>
                  <a:srgbClr val="000000"/>
                </a:solidFill>
                <a:latin typeface="Times New Roman"/>
                <a:ea typeface="宋体"/>
              </a:rPr>
              <a:t>mutants was not apparent at 10 min.  At 30 min, the dye remained on the plasma membrane, and weak fluorescence was seen internally at 90 min, which was likely due to diffusion (Fig. S1B). </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宋体"/>
              </a:rPr>
              <a:t>Reference</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宋体"/>
              </a:rPr>
              <a:t>Fischer-Parton, S., Parton, R.M., Hickey, P.C., Dijksterhuis, J., Atkinson, H.A., and Read, N.D. 2000. Confocal microscopy of FM4-64 as a tool for analysing endocytosis and vesicle trafficking in living fungal hyphae. J Microsc 198:246-259.</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sz="1200" spc="-1" strike="noStrike">
                <a:solidFill>
                  <a:srgbClr val="000000"/>
                </a:solidFill>
                <a:latin typeface="Times New Roman"/>
                <a:ea typeface="宋体"/>
              </a:rPr>
              <a:t>Weber, R.W., Wakley, G.E., Thines, E., and Talbot, N.J. 2001. The vacuole as central element of the lytic system and sink for lipid droplets in maturing appressoria of </a:t>
            </a:r>
            <a:r>
              <a:rPr b="0" i="1" sz="1200" spc="-1" strike="noStrike">
                <a:solidFill>
                  <a:srgbClr val="000000"/>
                </a:solidFill>
                <a:latin typeface="Times New Roman"/>
                <a:ea typeface="宋体"/>
              </a:rPr>
              <a:t>Magnaporthe grisea</a:t>
            </a:r>
            <a:r>
              <a:rPr b="0" sz="1200" spc="-1" strike="noStrike">
                <a:solidFill>
                  <a:srgbClr val="000000"/>
                </a:solidFill>
                <a:latin typeface="Times New Roman"/>
                <a:ea typeface="宋体"/>
              </a:rPr>
              <a:t>. Protoplasma 216, 101-112.</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31T15:52:05Z</dcterms:created>
  <dc:creator>Ping Wang</dc:creator>
  <dc:description/>
  <dc:language>en-US</dc:language>
  <cp:lastModifiedBy>Ping Wang</cp:lastModifiedBy>
  <dcterms:modified xsi:type="dcterms:W3CDTF">2010-08-31T15:56:58Z</dcterms:modified>
  <cp:revision>2</cp:revision>
  <dc:subject/>
  <dc:title>PowerPoint Presentation</dc:title>
</cp:coreProperties>
</file>